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FF2600"/>
    <a:srgbClr val="73F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15"/>
    <p:restoredTop sz="94637"/>
  </p:normalViewPr>
  <p:slideViewPr>
    <p:cSldViewPr snapToGrid="0" snapToObjects="1">
      <p:cViewPr varScale="1">
        <p:scale>
          <a:sx n="72" d="100"/>
          <a:sy n="72" d="100"/>
        </p:scale>
        <p:origin x="5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A3D307-269C-984D-A1D2-52936F998F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B1AF535-F3B6-1141-BEB8-55A60C51B5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46E097-25CC-DC4D-BC54-D85C0FB82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B514C9-3A17-7340-B692-7F5BAC2B8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172FC6-7EE6-0242-BB04-67527F8F3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896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95E2B3-8BC5-E74B-BAAF-9C860A2D2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690C341-905F-1D44-B878-3A2E462EAE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2EF610-7FA4-194A-9502-6ED7636D2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032D85-67CF-DA4F-8C04-D7B3F2B4C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CC7A90-36A6-D148-8AEC-C06BC67B3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958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08152F4-78C8-C745-B0B3-727B78D942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C477B50-B8A4-0D4A-AB08-744BD2EB91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C08B7D-E030-BC45-AE71-542B8DAD9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7515EE-07D9-9F41-915F-95D787008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E08033-D02E-C54F-8DAD-4B207FB08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1191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603210-4C08-6146-B131-E46B59678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87FA24F-BC80-6D40-A200-DB1C55718E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B02BD0-B03E-6843-9BDF-470D330BD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CC9C2D-F738-DF47-908D-CF6172812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496086-D9B7-F745-8751-C50FF734A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555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DF8ABB-8904-CE40-824D-AAB36851C2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D287A1-C19D-0F4B-8CDC-69E9657151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BD92DD-2479-B545-A28E-4ADB209CC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5B55DA-EFDF-8A42-B130-06DCBC89E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5EBD90-2ED5-6E4B-B05B-81E8AA916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307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CE5F6C-6FD4-0E40-9220-B181450B27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430BD49-79FE-FD46-9F78-172983E19B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BE4D10B-6E4B-274C-A7DA-DA93122383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4BFD09-E325-3C4B-8DC9-BC4BAE028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0A8058D-77D6-9043-9292-8B79738A4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135EA5-D35B-B94E-A09F-2553776CE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5599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0F27D2-1E96-3742-BC03-66FEA3451A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1B6DE0B-44FE-4543-A2E7-763AECD5FA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424C201-0578-974B-90B7-9DECFAACA3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2E60F21-5ECF-6E47-B909-016E2865BA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06B9C1E-AA45-524F-BAD5-019D2D6618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7B2DFAB-13C7-DE44-9341-37C3A9DD7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7F7B45-C2BD-7642-8EE0-523740200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EF8942C-8665-1D4C-B01D-0D7816B08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9148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957A53-8BFF-E843-AE8D-9DBB8D5113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1C848CF-65A5-F445-8944-1A270BDF6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34C5264-D71A-8144-88E2-A0403D247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8106233-2EF7-AD4C-B766-8AF85D13E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487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1D9B126-F9CC-1B41-B389-27372BD17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12222B9-42DC-A14F-BE7D-4E57C5094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D58E1E0-E621-8049-B957-1778D4C0D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3264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C62940-526C-C54F-93E9-CF542606B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4542BE-9D21-BB42-A61A-B9B883D0B4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0201F57-04EC-064C-95EE-3C4F062B53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62D425-3C9F-1344-A56B-E6F02DDFD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37698D7-5C06-0E43-9A9A-D7E3DEBB5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60D623-FF96-D942-9CF8-8E79EAFA5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8803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7FAFAF-0980-1743-AF2A-5A175AB14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7AD1791-B568-BA4E-8DC2-E5FCFBEDDD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A886163-B0A9-444F-B636-DC1177ADE6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5D97AF5-5B7E-6A4F-AB09-5A32E9146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287EE8-96B6-9A4D-B6E7-904205402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8788107-1E9C-6144-832B-7368EAA23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6159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02232A3-4388-5045-929E-8A4E552134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D5D317-5ADC-9C4D-852A-5EDD098CBD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428E2F-584F-A941-A65C-896ECF0F7C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480D49-33C8-4445-9800-81ED0617C3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7D3913-59AD-384A-A6E7-9D60D91E2E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681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0E61D9D1-8EB8-4E10-B092-4F6338C7E339}"/>
              </a:ext>
            </a:extLst>
          </p:cNvPr>
          <p:cNvSpPr txBox="1"/>
          <p:nvPr/>
        </p:nvSpPr>
        <p:spPr>
          <a:xfrm>
            <a:off x="2900526" y="333545"/>
            <a:ext cx="63909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S2 Fig.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gimoto A</a:t>
            </a:r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t al.</a:t>
            </a:r>
            <a:endParaRPr kumimoji="1" lang="ja-JP" altLang="en-US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3F59B72A-C95D-EC4F-8AD3-7F7A99CECB59}"/>
              </a:ext>
            </a:extLst>
          </p:cNvPr>
          <p:cNvCxnSpPr>
            <a:cxnSpLocks/>
          </p:cNvCxnSpPr>
          <p:nvPr/>
        </p:nvCxnSpPr>
        <p:spPr>
          <a:xfrm>
            <a:off x="1710101" y="2705640"/>
            <a:ext cx="0" cy="230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CC9D201B-E375-DB4F-8D3D-FF9FC3C0F1E7}"/>
              </a:ext>
            </a:extLst>
          </p:cNvPr>
          <p:cNvCxnSpPr>
            <a:cxnSpLocks/>
          </p:cNvCxnSpPr>
          <p:nvPr/>
        </p:nvCxnSpPr>
        <p:spPr>
          <a:xfrm flipH="1">
            <a:off x="1703419" y="5000675"/>
            <a:ext cx="35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ED95FBF-567A-7B4B-957D-09029907DE85}"/>
              </a:ext>
            </a:extLst>
          </p:cNvPr>
          <p:cNvSpPr txBox="1"/>
          <p:nvPr/>
        </p:nvSpPr>
        <p:spPr>
          <a:xfrm>
            <a:off x="1339133" y="4854744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969151A-AAB1-B446-86F5-22930CAE1B01}"/>
              </a:ext>
            </a:extLst>
          </p:cNvPr>
          <p:cNvSpPr txBox="1"/>
          <p:nvPr/>
        </p:nvSpPr>
        <p:spPr>
          <a:xfrm>
            <a:off x="5039150" y="500027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09AA209-F35A-4143-823A-36877EA9A643}"/>
              </a:ext>
            </a:extLst>
          </p:cNvPr>
          <p:cNvSpPr txBox="1"/>
          <p:nvPr/>
        </p:nvSpPr>
        <p:spPr>
          <a:xfrm>
            <a:off x="2705759" y="500027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2489AF63-15EF-424F-A28E-3F740750C129}"/>
              </a:ext>
            </a:extLst>
          </p:cNvPr>
          <p:cNvSpPr txBox="1"/>
          <p:nvPr/>
        </p:nvSpPr>
        <p:spPr>
          <a:xfrm>
            <a:off x="3872454" y="500027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C34DE32-235E-0747-BEB7-E7E1D9207206}"/>
              </a:ext>
            </a:extLst>
          </p:cNvPr>
          <p:cNvSpPr txBox="1"/>
          <p:nvPr/>
        </p:nvSpPr>
        <p:spPr>
          <a:xfrm>
            <a:off x="1339133" y="270563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40DB299-1401-CE48-87F7-7FD64E721F8A}"/>
              </a:ext>
            </a:extLst>
          </p:cNvPr>
          <p:cNvSpPr txBox="1"/>
          <p:nvPr/>
        </p:nvSpPr>
        <p:spPr>
          <a:xfrm>
            <a:off x="1339133" y="313898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B3FFB58-4895-8E41-AFC8-339589EF79D5}"/>
              </a:ext>
            </a:extLst>
          </p:cNvPr>
          <p:cNvSpPr txBox="1"/>
          <p:nvPr/>
        </p:nvSpPr>
        <p:spPr>
          <a:xfrm>
            <a:off x="1339133" y="357233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1BDEACE-3678-5841-9931-2B4783CB96FA}"/>
              </a:ext>
            </a:extLst>
          </p:cNvPr>
          <p:cNvSpPr txBox="1"/>
          <p:nvPr/>
        </p:nvSpPr>
        <p:spPr>
          <a:xfrm>
            <a:off x="1339133" y="400568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B278739-F4B7-4F4D-A904-F8345F2C5B3E}"/>
              </a:ext>
            </a:extLst>
          </p:cNvPr>
          <p:cNvSpPr txBox="1"/>
          <p:nvPr/>
        </p:nvSpPr>
        <p:spPr>
          <a:xfrm>
            <a:off x="1339133" y="4439039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E391A37-C50E-FB4C-BA11-CDFE9F310E09}"/>
              </a:ext>
            </a:extLst>
          </p:cNvPr>
          <p:cNvSpPr txBox="1"/>
          <p:nvPr/>
        </p:nvSpPr>
        <p:spPr>
          <a:xfrm rot="16200000">
            <a:off x="572706" y="3703846"/>
            <a:ext cx="12522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al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A4C9352-BA35-A349-8FF8-137A59CF2B89}"/>
              </a:ext>
            </a:extLst>
          </p:cNvPr>
          <p:cNvSpPr txBox="1"/>
          <p:nvPr/>
        </p:nvSpPr>
        <p:spPr>
          <a:xfrm>
            <a:off x="2693151" y="5204549"/>
            <a:ext cx="1584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 after surgery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6FD90FFE-EF61-FF41-9248-2D4C45F6FB3E}"/>
              </a:ext>
            </a:extLst>
          </p:cNvPr>
          <p:cNvCxnSpPr>
            <a:cxnSpLocks/>
          </p:cNvCxnSpPr>
          <p:nvPr/>
        </p:nvCxnSpPr>
        <p:spPr>
          <a:xfrm>
            <a:off x="1640384" y="28441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AB8BE834-7A65-8647-87F7-EF1B0C4E87CE}"/>
              </a:ext>
            </a:extLst>
          </p:cNvPr>
          <p:cNvCxnSpPr>
            <a:cxnSpLocks/>
          </p:cNvCxnSpPr>
          <p:nvPr/>
        </p:nvCxnSpPr>
        <p:spPr>
          <a:xfrm>
            <a:off x="1640384" y="327748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FCE3BB8F-1A95-F54F-9DBF-91C7151B6556}"/>
              </a:ext>
            </a:extLst>
          </p:cNvPr>
          <p:cNvCxnSpPr>
            <a:cxnSpLocks/>
          </p:cNvCxnSpPr>
          <p:nvPr/>
        </p:nvCxnSpPr>
        <p:spPr>
          <a:xfrm>
            <a:off x="1640384" y="37108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ACE0CA64-3913-8E4B-9A13-8C20584B7AF2}"/>
              </a:ext>
            </a:extLst>
          </p:cNvPr>
          <p:cNvCxnSpPr>
            <a:cxnSpLocks/>
          </p:cNvCxnSpPr>
          <p:nvPr/>
        </p:nvCxnSpPr>
        <p:spPr>
          <a:xfrm>
            <a:off x="1640384" y="414418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30C6BEAD-2BD8-0E41-8724-C21ABC7F0FD3}"/>
              </a:ext>
            </a:extLst>
          </p:cNvPr>
          <p:cNvCxnSpPr>
            <a:cxnSpLocks/>
          </p:cNvCxnSpPr>
          <p:nvPr/>
        </p:nvCxnSpPr>
        <p:spPr>
          <a:xfrm>
            <a:off x="1640384" y="457753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E57A697D-F0C6-D744-9E85-A0AC78174F7A}"/>
              </a:ext>
            </a:extLst>
          </p:cNvPr>
          <p:cNvCxnSpPr>
            <a:cxnSpLocks/>
          </p:cNvCxnSpPr>
          <p:nvPr/>
        </p:nvCxnSpPr>
        <p:spPr>
          <a:xfrm>
            <a:off x="1640384" y="5000658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E0200279-E5BB-7946-85DA-17DCD7257A54}"/>
              </a:ext>
            </a:extLst>
          </p:cNvPr>
          <p:cNvCxnSpPr>
            <a:cxnSpLocks/>
          </p:cNvCxnSpPr>
          <p:nvPr/>
        </p:nvCxnSpPr>
        <p:spPr>
          <a:xfrm>
            <a:off x="1710101" y="4998617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56EA63BC-E25D-0E4E-9477-FE145CE71532}"/>
              </a:ext>
            </a:extLst>
          </p:cNvPr>
          <p:cNvCxnSpPr>
            <a:cxnSpLocks/>
          </p:cNvCxnSpPr>
          <p:nvPr/>
        </p:nvCxnSpPr>
        <p:spPr>
          <a:xfrm>
            <a:off x="2876209" y="4998617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654555EF-C4A5-1A44-A661-8E51F23CB0C1}"/>
              </a:ext>
            </a:extLst>
          </p:cNvPr>
          <p:cNvCxnSpPr>
            <a:cxnSpLocks/>
          </p:cNvCxnSpPr>
          <p:nvPr/>
        </p:nvCxnSpPr>
        <p:spPr>
          <a:xfrm>
            <a:off x="4042317" y="4998617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7DE161F1-88BE-A942-848F-99314C8A5916}"/>
              </a:ext>
            </a:extLst>
          </p:cNvPr>
          <p:cNvCxnSpPr>
            <a:cxnSpLocks/>
          </p:cNvCxnSpPr>
          <p:nvPr/>
        </p:nvCxnSpPr>
        <p:spPr>
          <a:xfrm>
            <a:off x="5208427" y="4998617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B5E71839-E980-2A4F-AD8A-5BCDF4460CFE}"/>
              </a:ext>
            </a:extLst>
          </p:cNvPr>
          <p:cNvCxnSpPr>
            <a:cxnSpLocks/>
          </p:cNvCxnSpPr>
          <p:nvPr/>
        </p:nvCxnSpPr>
        <p:spPr>
          <a:xfrm>
            <a:off x="2293155" y="4998617"/>
            <a:ext cx="0" cy="3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40925A78-7F7F-1F42-A7C1-45236A4B0DFD}"/>
              </a:ext>
            </a:extLst>
          </p:cNvPr>
          <p:cNvCxnSpPr>
            <a:cxnSpLocks/>
          </p:cNvCxnSpPr>
          <p:nvPr/>
        </p:nvCxnSpPr>
        <p:spPr>
          <a:xfrm>
            <a:off x="3459263" y="4998617"/>
            <a:ext cx="0" cy="3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C8024A97-6C10-7B49-B740-D47B16BF878B}"/>
              </a:ext>
            </a:extLst>
          </p:cNvPr>
          <p:cNvCxnSpPr>
            <a:cxnSpLocks/>
          </p:cNvCxnSpPr>
          <p:nvPr/>
        </p:nvCxnSpPr>
        <p:spPr>
          <a:xfrm>
            <a:off x="4625371" y="4998617"/>
            <a:ext cx="0" cy="3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EBBB4B5-1E47-A347-BE0F-466068D502A6}"/>
              </a:ext>
            </a:extLst>
          </p:cNvPr>
          <p:cNvSpPr txBox="1"/>
          <p:nvPr/>
        </p:nvSpPr>
        <p:spPr>
          <a:xfrm>
            <a:off x="1577535" y="500027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3825F1CE-7B7B-498E-8945-817C0E13CD58}"/>
              </a:ext>
            </a:extLst>
          </p:cNvPr>
          <p:cNvSpPr txBox="1"/>
          <p:nvPr/>
        </p:nvSpPr>
        <p:spPr>
          <a:xfrm>
            <a:off x="2154333" y="2204281"/>
            <a:ext cx="21905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patients (n=110)</a:t>
            </a:r>
            <a:endParaRPr kumimoji="1" lang="ja-JP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1BEF6BB4-21C5-4241-A280-0D3AFEE84E55}"/>
              </a:ext>
            </a:extLst>
          </p:cNvPr>
          <p:cNvSpPr txBox="1"/>
          <p:nvPr/>
        </p:nvSpPr>
        <p:spPr>
          <a:xfrm>
            <a:off x="1060339" y="1950042"/>
            <a:ext cx="313935" cy="369332"/>
          </a:xfrm>
          <a:prstGeom prst="rect">
            <a:avLst/>
          </a:pr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kumimoji="1"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2D1D39B3-C477-694F-967B-50E6A919AA60}"/>
              </a:ext>
            </a:extLst>
          </p:cNvPr>
          <p:cNvCxnSpPr>
            <a:cxnSpLocks/>
          </p:cNvCxnSpPr>
          <p:nvPr/>
        </p:nvCxnSpPr>
        <p:spPr>
          <a:xfrm>
            <a:off x="6904639" y="2704279"/>
            <a:ext cx="0" cy="230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EBCAAE5F-5251-374E-825D-1292A4DA95E9}"/>
              </a:ext>
            </a:extLst>
          </p:cNvPr>
          <p:cNvCxnSpPr>
            <a:cxnSpLocks/>
          </p:cNvCxnSpPr>
          <p:nvPr/>
        </p:nvCxnSpPr>
        <p:spPr>
          <a:xfrm flipH="1">
            <a:off x="6897957" y="4999314"/>
            <a:ext cx="35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EDE4D67-6D64-BF4D-A0C9-54A885083C8D}"/>
              </a:ext>
            </a:extLst>
          </p:cNvPr>
          <p:cNvSpPr txBox="1"/>
          <p:nvPr/>
        </p:nvSpPr>
        <p:spPr>
          <a:xfrm>
            <a:off x="6533671" y="4853383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48A8898-D0C5-D24B-BA2A-7E7FEC119A0D}"/>
              </a:ext>
            </a:extLst>
          </p:cNvPr>
          <p:cNvSpPr txBox="1"/>
          <p:nvPr/>
        </p:nvSpPr>
        <p:spPr>
          <a:xfrm>
            <a:off x="10233688" y="49989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CBE4D84-2C96-8942-82AB-BAAA079893C0}"/>
              </a:ext>
            </a:extLst>
          </p:cNvPr>
          <p:cNvSpPr txBox="1"/>
          <p:nvPr/>
        </p:nvSpPr>
        <p:spPr>
          <a:xfrm>
            <a:off x="7900297" y="49989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805327F-9261-0343-9650-AD55C7CB6F49}"/>
              </a:ext>
            </a:extLst>
          </p:cNvPr>
          <p:cNvSpPr txBox="1"/>
          <p:nvPr/>
        </p:nvSpPr>
        <p:spPr>
          <a:xfrm>
            <a:off x="9066992" y="49989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761B831-7E83-404B-8824-9DA942450D99}"/>
              </a:ext>
            </a:extLst>
          </p:cNvPr>
          <p:cNvSpPr txBox="1"/>
          <p:nvPr/>
        </p:nvSpPr>
        <p:spPr>
          <a:xfrm>
            <a:off x="6533671" y="2704278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DB5F44E-2097-CF42-8DBF-77A4FDD33FA2}"/>
              </a:ext>
            </a:extLst>
          </p:cNvPr>
          <p:cNvSpPr txBox="1"/>
          <p:nvPr/>
        </p:nvSpPr>
        <p:spPr>
          <a:xfrm>
            <a:off x="6533671" y="3137628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2CD737D-8582-B246-8A9B-AF54D8253339}"/>
              </a:ext>
            </a:extLst>
          </p:cNvPr>
          <p:cNvSpPr txBox="1"/>
          <p:nvPr/>
        </p:nvSpPr>
        <p:spPr>
          <a:xfrm>
            <a:off x="6533671" y="3570978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C97194F-4B43-254E-8E2D-1F9A4426B90C}"/>
              </a:ext>
            </a:extLst>
          </p:cNvPr>
          <p:cNvSpPr txBox="1"/>
          <p:nvPr/>
        </p:nvSpPr>
        <p:spPr>
          <a:xfrm>
            <a:off x="6533671" y="4004328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6C5E112-98E7-944C-9119-5AE9314B832E}"/>
              </a:ext>
            </a:extLst>
          </p:cNvPr>
          <p:cNvSpPr txBox="1"/>
          <p:nvPr/>
        </p:nvSpPr>
        <p:spPr>
          <a:xfrm>
            <a:off x="6533671" y="4437678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09AAFCC-386B-3B4E-BC06-58645DAF7486}"/>
              </a:ext>
            </a:extLst>
          </p:cNvPr>
          <p:cNvSpPr txBox="1"/>
          <p:nvPr/>
        </p:nvSpPr>
        <p:spPr>
          <a:xfrm rot="16200000">
            <a:off x="5956401" y="3702485"/>
            <a:ext cx="873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FS rate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31B1AA8-C605-BA44-87A0-2F1C1304139F}"/>
              </a:ext>
            </a:extLst>
          </p:cNvPr>
          <p:cNvSpPr txBox="1"/>
          <p:nvPr/>
        </p:nvSpPr>
        <p:spPr>
          <a:xfrm>
            <a:off x="8024138" y="5204549"/>
            <a:ext cx="1584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 after surgery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1FC73B9F-423F-8F43-9B6B-16486A27AC4C}"/>
              </a:ext>
            </a:extLst>
          </p:cNvPr>
          <p:cNvCxnSpPr>
            <a:cxnSpLocks/>
          </p:cNvCxnSpPr>
          <p:nvPr/>
        </p:nvCxnSpPr>
        <p:spPr>
          <a:xfrm>
            <a:off x="6834922" y="284277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960E2C55-ABAC-1441-ADBB-CE4F1E0BA67F}"/>
              </a:ext>
            </a:extLst>
          </p:cNvPr>
          <p:cNvCxnSpPr>
            <a:cxnSpLocks/>
          </p:cNvCxnSpPr>
          <p:nvPr/>
        </p:nvCxnSpPr>
        <p:spPr>
          <a:xfrm>
            <a:off x="6834922" y="327612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8362FCF0-83F6-9F4A-9DF6-2F148D059C55}"/>
              </a:ext>
            </a:extLst>
          </p:cNvPr>
          <p:cNvCxnSpPr>
            <a:cxnSpLocks/>
          </p:cNvCxnSpPr>
          <p:nvPr/>
        </p:nvCxnSpPr>
        <p:spPr>
          <a:xfrm>
            <a:off x="6834922" y="370947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0D689AC4-7D34-834C-9130-98D42ECEF835}"/>
              </a:ext>
            </a:extLst>
          </p:cNvPr>
          <p:cNvCxnSpPr>
            <a:cxnSpLocks/>
          </p:cNvCxnSpPr>
          <p:nvPr/>
        </p:nvCxnSpPr>
        <p:spPr>
          <a:xfrm>
            <a:off x="6834922" y="414282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5A46DEFC-3F07-7D46-A21F-5A56743E39F2}"/>
              </a:ext>
            </a:extLst>
          </p:cNvPr>
          <p:cNvCxnSpPr>
            <a:cxnSpLocks/>
          </p:cNvCxnSpPr>
          <p:nvPr/>
        </p:nvCxnSpPr>
        <p:spPr>
          <a:xfrm>
            <a:off x="6834922" y="457617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D09F43A9-9F58-6D46-849A-B57940F17B33}"/>
              </a:ext>
            </a:extLst>
          </p:cNvPr>
          <p:cNvCxnSpPr>
            <a:cxnSpLocks/>
          </p:cNvCxnSpPr>
          <p:nvPr/>
        </p:nvCxnSpPr>
        <p:spPr>
          <a:xfrm>
            <a:off x="6834922" y="499929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765EBDB7-72F8-5A43-8E97-5463301482C7}"/>
              </a:ext>
            </a:extLst>
          </p:cNvPr>
          <p:cNvCxnSpPr>
            <a:cxnSpLocks/>
          </p:cNvCxnSpPr>
          <p:nvPr/>
        </p:nvCxnSpPr>
        <p:spPr>
          <a:xfrm>
            <a:off x="6904639" y="4997256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25637DFC-FBF7-A043-A1D1-878EC367DEAA}"/>
              </a:ext>
            </a:extLst>
          </p:cNvPr>
          <p:cNvCxnSpPr>
            <a:cxnSpLocks/>
          </p:cNvCxnSpPr>
          <p:nvPr/>
        </p:nvCxnSpPr>
        <p:spPr>
          <a:xfrm>
            <a:off x="8070747" y="4997256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E5B33A23-4E2C-814F-9B8F-F7EA32C3AEEC}"/>
              </a:ext>
            </a:extLst>
          </p:cNvPr>
          <p:cNvCxnSpPr>
            <a:cxnSpLocks/>
          </p:cNvCxnSpPr>
          <p:nvPr/>
        </p:nvCxnSpPr>
        <p:spPr>
          <a:xfrm>
            <a:off x="9236855" y="4997256"/>
            <a:ext cx="0" cy="72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AD00AB62-44FF-4441-86DB-756CD8F475A9}"/>
              </a:ext>
            </a:extLst>
          </p:cNvPr>
          <p:cNvCxnSpPr>
            <a:cxnSpLocks/>
          </p:cNvCxnSpPr>
          <p:nvPr/>
        </p:nvCxnSpPr>
        <p:spPr>
          <a:xfrm>
            <a:off x="7487693" y="4997256"/>
            <a:ext cx="0" cy="3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89742315-175F-1242-85E4-03A0F2700AA4}"/>
              </a:ext>
            </a:extLst>
          </p:cNvPr>
          <p:cNvCxnSpPr>
            <a:cxnSpLocks/>
          </p:cNvCxnSpPr>
          <p:nvPr/>
        </p:nvCxnSpPr>
        <p:spPr>
          <a:xfrm>
            <a:off x="8653801" y="4997256"/>
            <a:ext cx="0" cy="3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DCABBF6B-51A7-A742-9002-578F517BD79A}"/>
              </a:ext>
            </a:extLst>
          </p:cNvPr>
          <p:cNvCxnSpPr>
            <a:cxnSpLocks/>
          </p:cNvCxnSpPr>
          <p:nvPr/>
        </p:nvCxnSpPr>
        <p:spPr>
          <a:xfrm>
            <a:off x="9819909" y="4997256"/>
            <a:ext cx="0" cy="3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CF209AD-FE06-5149-A71E-F1F8C3D17119}"/>
              </a:ext>
            </a:extLst>
          </p:cNvPr>
          <p:cNvSpPr txBox="1"/>
          <p:nvPr/>
        </p:nvSpPr>
        <p:spPr>
          <a:xfrm>
            <a:off x="6772073" y="499891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16A27723-D94F-44C7-86BD-DAC016D63E18}"/>
              </a:ext>
            </a:extLst>
          </p:cNvPr>
          <p:cNvSpPr txBox="1"/>
          <p:nvPr/>
        </p:nvSpPr>
        <p:spPr>
          <a:xfrm>
            <a:off x="6579588" y="2153316"/>
            <a:ext cx="43620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R0 curative operation (n=98)</a:t>
            </a:r>
            <a:endParaRPr kumimoji="1" lang="ja-JP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6E1F1F46-79EC-4390-8327-9338C114B44B}"/>
              </a:ext>
            </a:extLst>
          </p:cNvPr>
          <p:cNvSpPr txBox="1"/>
          <p:nvPr/>
        </p:nvSpPr>
        <p:spPr>
          <a:xfrm>
            <a:off x="6079443" y="1868960"/>
            <a:ext cx="313935" cy="369332"/>
          </a:xfrm>
          <a:prstGeom prst="rect">
            <a:avLst/>
          </a:pr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kumimoji="1"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0" name="図 69">
            <a:extLst>
              <a:ext uri="{FF2B5EF4-FFF2-40B4-BE49-F238E27FC236}">
                <a16:creationId xmlns:a16="http://schemas.microsoft.com/office/drawing/2014/main" id="{BBC4A017-9B04-E446-BA55-80E2D5E7CC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502" t="6495" r="3607" b="20331"/>
          <a:stretch/>
        </p:blipFill>
        <p:spPr>
          <a:xfrm>
            <a:off x="1720396" y="2791277"/>
            <a:ext cx="3510579" cy="2146704"/>
          </a:xfrm>
          <a:prstGeom prst="rect">
            <a:avLst/>
          </a:prstGeom>
        </p:spPr>
      </p:pic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C88CDD32-3A86-CE40-8035-22BD22702EB2}"/>
              </a:ext>
            </a:extLst>
          </p:cNvPr>
          <p:cNvSpPr txBox="1"/>
          <p:nvPr/>
        </p:nvSpPr>
        <p:spPr>
          <a:xfrm>
            <a:off x="3782709" y="3504955"/>
            <a:ext cx="1532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s5-positive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90)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E2131F2A-E112-F64C-9533-BAA7A19BDEB1}"/>
              </a:ext>
            </a:extLst>
          </p:cNvPr>
          <p:cNvSpPr txBox="1"/>
          <p:nvPr/>
        </p:nvSpPr>
        <p:spPr>
          <a:xfrm>
            <a:off x="4352923" y="3123123"/>
            <a:ext cx="11126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192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8718DF67-6287-724F-BF6F-6086AA20792F}"/>
              </a:ext>
            </a:extLst>
          </p:cNvPr>
          <p:cNvSpPr txBox="1"/>
          <p:nvPr/>
        </p:nvSpPr>
        <p:spPr>
          <a:xfrm>
            <a:off x="3782709" y="2889914"/>
            <a:ext cx="1576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s5-negative (n=20)</a:t>
            </a:r>
          </a:p>
        </p:txBody>
      </p:sp>
      <p:pic>
        <p:nvPicPr>
          <p:cNvPr id="84" name="図 83">
            <a:extLst>
              <a:ext uri="{FF2B5EF4-FFF2-40B4-BE49-F238E27FC236}">
                <a16:creationId xmlns:a16="http://schemas.microsoft.com/office/drawing/2014/main" id="{B0C4EFAA-EAD7-084D-BB4D-5A1AF471BBD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535" t="5242" r="3574" b="27869"/>
          <a:stretch/>
        </p:blipFill>
        <p:spPr>
          <a:xfrm>
            <a:off x="6911322" y="2754679"/>
            <a:ext cx="3510579" cy="1962328"/>
          </a:xfrm>
          <a:prstGeom prst="rect">
            <a:avLst/>
          </a:prstGeom>
        </p:spPr>
      </p:pic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1648393-111B-6443-ADC3-1F8ED37A8A05}"/>
              </a:ext>
            </a:extLst>
          </p:cNvPr>
          <p:cNvSpPr txBox="1"/>
          <p:nvPr/>
        </p:nvSpPr>
        <p:spPr>
          <a:xfrm>
            <a:off x="8951557" y="3158333"/>
            <a:ext cx="1532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s5-positive (n=80)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967327D6-0AFB-A446-AEAE-0E6052F2D720}"/>
              </a:ext>
            </a:extLst>
          </p:cNvPr>
          <p:cNvSpPr txBox="1"/>
          <p:nvPr/>
        </p:nvSpPr>
        <p:spPr>
          <a:xfrm>
            <a:off x="9488695" y="2895067"/>
            <a:ext cx="11126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9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B59088D6-8DFF-5E48-B3A9-93195E837986}"/>
              </a:ext>
            </a:extLst>
          </p:cNvPr>
          <p:cNvSpPr txBox="1"/>
          <p:nvPr/>
        </p:nvSpPr>
        <p:spPr>
          <a:xfrm>
            <a:off x="8905120" y="2702992"/>
            <a:ext cx="1576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s5-negative (n=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095915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3</TotalTime>
  <Words>88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杉本　敦史</dc:creator>
  <cp:lastModifiedBy>chn off31</cp:lastModifiedBy>
  <cp:revision>113</cp:revision>
  <dcterms:created xsi:type="dcterms:W3CDTF">2020-12-10T23:24:33Z</dcterms:created>
  <dcterms:modified xsi:type="dcterms:W3CDTF">2021-07-06T03:33:01Z</dcterms:modified>
</cp:coreProperties>
</file>